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73" d="100"/>
          <a:sy n="73" d="100"/>
        </p:scale>
        <p:origin x="67" y="6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4" Type="http://schemas.openxmlformats.org/officeDocument/2006/relationships/image" Target="../media/image4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843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63917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0695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64789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66848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09386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37682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49402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3841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8344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1027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84570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wmf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1388326" y="1419500"/>
            <a:ext cx="1785031" cy="0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3343060" y="1419500"/>
            <a:ext cx="2284038" cy="1977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2053244" y="1039089"/>
            <a:ext cx="7441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aline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42286" y="2323981"/>
            <a:ext cx="7970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SK3</a:t>
            </a:r>
            <a:r>
              <a:rPr lang="el-GR" dirty="0" smtClean="0"/>
              <a:t>β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3893129" y="1050168"/>
            <a:ext cx="9714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icotine</a:t>
            </a:r>
            <a:endParaRPr lang="en-US" dirty="0"/>
          </a:p>
        </p:txBody>
      </p:sp>
      <p:cxnSp>
        <p:nvCxnSpPr>
          <p:cNvPr id="15" name="Straight Connector 14"/>
          <p:cNvCxnSpPr/>
          <p:nvPr/>
        </p:nvCxnSpPr>
        <p:spPr>
          <a:xfrm>
            <a:off x="7445079" y="1821825"/>
            <a:ext cx="1694469" cy="1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 flipV="1">
            <a:off x="9217572" y="1814083"/>
            <a:ext cx="2015692" cy="7742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7570781" y="1496472"/>
            <a:ext cx="12634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Saline+NAC</a:t>
            </a:r>
            <a:endParaRPr 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9447358" y="1467713"/>
            <a:ext cx="14907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Nicotine+NAC</a:t>
            </a:r>
            <a:endParaRPr lang="en-US" dirty="0"/>
          </a:p>
        </p:txBody>
      </p:sp>
      <p:sp>
        <p:nvSpPr>
          <p:cNvPr id="26" name="TextBox 25"/>
          <p:cNvSpPr txBox="1"/>
          <p:nvPr/>
        </p:nvSpPr>
        <p:spPr>
          <a:xfrm>
            <a:off x="82417" y="4795858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ADPH</a:t>
            </a:r>
            <a:endParaRPr lang="en-US" dirty="0"/>
          </a:p>
        </p:txBody>
      </p:sp>
      <p:cxnSp>
        <p:nvCxnSpPr>
          <p:cNvPr id="30" name="Straight Arrow Connector 29"/>
          <p:cNvCxnSpPr/>
          <p:nvPr/>
        </p:nvCxnSpPr>
        <p:spPr>
          <a:xfrm>
            <a:off x="887532" y="4988835"/>
            <a:ext cx="270708" cy="1567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/>
          <p:nvPr/>
        </p:nvCxnSpPr>
        <p:spPr>
          <a:xfrm>
            <a:off x="7030621" y="2498011"/>
            <a:ext cx="270708" cy="1567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6292717" y="4764431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ADPH</a:t>
            </a:r>
            <a:endParaRPr lang="en-US" dirty="0"/>
          </a:p>
        </p:txBody>
      </p:sp>
      <p:cxnSp>
        <p:nvCxnSpPr>
          <p:cNvPr id="34" name="Straight Arrow Connector 33"/>
          <p:cNvCxnSpPr/>
          <p:nvPr/>
        </p:nvCxnSpPr>
        <p:spPr>
          <a:xfrm>
            <a:off x="7097832" y="4987014"/>
            <a:ext cx="270708" cy="1567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1136116" y="66675"/>
            <a:ext cx="958467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The original blot images which we generated for Figure </a:t>
            </a:r>
            <a:r>
              <a:rPr lang="en-US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6B.</a:t>
            </a:r>
            <a:endParaRPr 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6187163" y="2308723"/>
            <a:ext cx="7970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SK3</a:t>
            </a:r>
            <a:r>
              <a:rPr lang="el-GR" dirty="0" smtClean="0"/>
              <a:t>β</a:t>
            </a:r>
            <a:endParaRPr lang="en-US" dirty="0"/>
          </a:p>
        </p:txBody>
      </p:sp>
      <p:graphicFrame>
        <p:nvGraphicFramePr>
          <p:cNvPr id="38" name="Object 3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2632653"/>
              </p:ext>
            </p:extLst>
          </p:nvPr>
        </p:nvGraphicFramePr>
        <p:xfrm>
          <a:off x="1228992" y="1607253"/>
          <a:ext cx="4598952" cy="1914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5" name="Image" r:id="rId3" imgW="5714280" imgH="1914120" progId="Photoshop.Image.13">
                  <p:embed/>
                </p:oleObj>
              </mc:Choice>
              <mc:Fallback>
                <p:oleObj name="Image" r:id="rId3" imgW="5714280" imgH="191412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228992" y="1607253"/>
                        <a:ext cx="4598952" cy="1914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45" name="Straight Arrow Connector 44"/>
          <p:cNvCxnSpPr>
            <a:stCxn id="10" idx="3"/>
          </p:cNvCxnSpPr>
          <p:nvPr/>
        </p:nvCxnSpPr>
        <p:spPr>
          <a:xfrm flipV="1">
            <a:off x="839299" y="2500637"/>
            <a:ext cx="591067" cy="801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49" name="Object 4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06855376"/>
              </p:ext>
            </p:extLst>
          </p:nvPr>
        </p:nvGraphicFramePr>
        <p:xfrm>
          <a:off x="1198658" y="4288169"/>
          <a:ext cx="4640575" cy="17749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6" name="Image" r:id="rId5" imgW="6247440" imgH="1161720" progId="Photoshop.Image.13">
                  <p:embed/>
                </p:oleObj>
              </mc:Choice>
              <mc:Fallback>
                <p:oleObj name="Image" r:id="rId5" imgW="6247440" imgH="116172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198658" y="4288169"/>
                        <a:ext cx="4640575" cy="17749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" name="Object 4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11283920"/>
              </p:ext>
            </p:extLst>
          </p:nvPr>
        </p:nvGraphicFramePr>
        <p:xfrm>
          <a:off x="7343369" y="2147178"/>
          <a:ext cx="4160837" cy="9812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7" name="Image" r:id="rId7" imgW="4161600" imgH="1018800" progId="Photoshop.Image.13">
                  <p:embed/>
                </p:oleObj>
              </mc:Choice>
              <mc:Fallback>
                <p:oleObj name="Image" r:id="rId7" imgW="4161600" imgH="101880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343369" y="2147178"/>
                        <a:ext cx="4160837" cy="98123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55" name="Straight Connector 54"/>
          <p:cNvCxnSpPr/>
          <p:nvPr/>
        </p:nvCxnSpPr>
        <p:spPr>
          <a:xfrm flipH="1" flipV="1">
            <a:off x="3300248" y="1376855"/>
            <a:ext cx="42812" cy="3156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>
            <a:off x="3258208" y="1039089"/>
            <a:ext cx="0" cy="4902388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60" name="Object 5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71319372"/>
              </p:ext>
            </p:extLst>
          </p:nvPr>
        </p:nvGraphicFramePr>
        <p:xfrm>
          <a:off x="7368784" y="4385387"/>
          <a:ext cx="4135422" cy="12592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8" name="Image" r:id="rId9" imgW="6704640" imgH="1542600" progId="Photoshop.Image.13">
                  <p:embed/>
                </p:oleObj>
              </mc:Choice>
              <mc:Fallback>
                <p:oleObj name="Image" r:id="rId9" imgW="6704640" imgH="154260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7368784" y="4385387"/>
                        <a:ext cx="4135422" cy="12592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62" name="Straight Connector 61"/>
          <p:cNvCxnSpPr/>
          <p:nvPr/>
        </p:nvCxnSpPr>
        <p:spPr>
          <a:xfrm>
            <a:off x="9177252" y="1496472"/>
            <a:ext cx="65259" cy="4364001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333028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</TotalTime>
  <Words>21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Adobe Photoshop Image</vt:lpstr>
      <vt:lpstr>PowerPoint Presentation</vt:lpstr>
    </vt:vector>
  </TitlesOfParts>
  <Company>Loma Linda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ao, Daliao (LLU)</dc:creator>
  <cp:lastModifiedBy>Xiao, Daliao (LLU)</cp:lastModifiedBy>
  <cp:revision>15</cp:revision>
  <dcterms:created xsi:type="dcterms:W3CDTF">2015-12-16T17:26:50Z</dcterms:created>
  <dcterms:modified xsi:type="dcterms:W3CDTF">2015-12-17T23:12:57Z</dcterms:modified>
</cp:coreProperties>
</file>